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464" y="-9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/>
          <p:cNvGrpSpPr/>
          <p:nvPr/>
        </p:nvGrpSpPr>
        <p:grpSpPr>
          <a:xfrm>
            <a:off x="107504" y="620688"/>
            <a:ext cx="8964489" cy="5170948"/>
            <a:chOff x="179511" y="211560"/>
            <a:chExt cx="8964489" cy="5170948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27" t="46544" r="43469" b="24735"/>
            <a:stretch/>
          </p:blipFill>
          <p:spPr>
            <a:xfrm>
              <a:off x="1358115" y="223202"/>
              <a:ext cx="1847461" cy="1744825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683" t="56634" r="56562" b="19867"/>
            <a:stretch/>
          </p:blipFill>
          <p:spPr>
            <a:xfrm>
              <a:off x="7230734" y="234965"/>
              <a:ext cx="1913266" cy="1682353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755" t="66971" r="47347" b="15059"/>
            <a:stretch/>
          </p:blipFill>
          <p:spPr>
            <a:xfrm>
              <a:off x="3295145" y="223202"/>
              <a:ext cx="2128708" cy="1705882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56" t="24558" r="39914" b="50715"/>
            <a:stretch/>
          </p:blipFill>
          <p:spPr>
            <a:xfrm>
              <a:off x="5435193" y="211560"/>
              <a:ext cx="1728192" cy="1717524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922708" y="2276872"/>
              <a:ext cx="718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0DAH</a:t>
              </a:r>
              <a:endParaRPr lang="zh-CN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828230" y="2276872"/>
              <a:ext cx="718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5DAH</a:t>
              </a:r>
              <a:endParaRPr lang="zh-CN" alt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868144" y="2276872"/>
              <a:ext cx="718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3DAH</a:t>
              </a:r>
              <a:endParaRPr lang="zh-CN" alt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000362" y="2276872"/>
              <a:ext cx="718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1DAH</a:t>
              </a:r>
              <a:endParaRPr lang="zh-CN" alt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79512" y="891475"/>
              <a:ext cx="11063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Wild-type</a:t>
              </a:r>
              <a:endParaRPr lang="zh-CN" altLang="en-US" dirty="0"/>
            </a:p>
          </p:txBody>
        </p:sp>
        <p:pic>
          <p:nvPicPr>
            <p:cNvPr id="13" name="图片 1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114" t="71429" r="54906" b="9542"/>
            <a:stretch/>
          </p:blipFill>
          <p:spPr>
            <a:xfrm>
              <a:off x="3295145" y="2905269"/>
              <a:ext cx="1947014" cy="1760873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03" t="31930" r="52464" b="52469"/>
            <a:stretch/>
          </p:blipFill>
          <p:spPr>
            <a:xfrm>
              <a:off x="5364088" y="2905268"/>
              <a:ext cx="1976252" cy="1760873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32" t="39445" r="59105" b="39821"/>
            <a:stretch/>
          </p:blipFill>
          <p:spPr>
            <a:xfrm>
              <a:off x="7429517" y="2902834"/>
              <a:ext cx="1684937" cy="1763307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286" t="23813" r="42245" b="57080"/>
            <a:stretch/>
          </p:blipFill>
          <p:spPr>
            <a:xfrm>
              <a:off x="1358115" y="2924944"/>
              <a:ext cx="1847461" cy="1741198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1922708" y="5013176"/>
              <a:ext cx="718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0DAH</a:t>
              </a:r>
              <a:endParaRPr lang="zh-CN" altLang="en-US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828230" y="5013176"/>
              <a:ext cx="718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5DAH</a:t>
              </a:r>
              <a:endParaRPr lang="zh-CN" altLang="en-US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868144" y="5013176"/>
              <a:ext cx="718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3DAH</a:t>
              </a:r>
              <a:endParaRPr lang="zh-CN" altLang="en-US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000362" y="5013176"/>
              <a:ext cx="718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1DAH</a:t>
              </a:r>
              <a:endParaRPr lang="zh-CN" altLang="en-US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79511" y="3601038"/>
              <a:ext cx="8181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PAT-11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8894590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520" y="1412776"/>
            <a:ext cx="871296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cs typeface="Times New Roman" pitchFamily="18" charset="0"/>
              </a:rPr>
              <a:t>Fig. </a:t>
            </a:r>
            <a:r>
              <a:rPr lang="en-US" altLang="zh-CN" dirty="0" smtClean="0">
                <a:cs typeface="Times New Roman" pitchFamily="18" charset="0"/>
              </a:rPr>
              <a:t>S3 </a:t>
            </a:r>
            <a:r>
              <a:rPr lang="en-US" altLang="zh-CN" b="1" dirty="0" smtClean="0">
                <a:cs typeface="Times New Roman" pitchFamily="18" charset="0"/>
              </a:rPr>
              <a:t>Fluorescence of scopoletin and scopolin in cassava roots was verified under UV light. </a:t>
            </a:r>
            <a:r>
              <a:rPr lang="en-US" altLang="zh-CN" dirty="0" smtClean="0">
                <a:cs typeface="Times New Roman" pitchFamily="18" charset="0"/>
              </a:rPr>
              <a:t>A wild-type root (upper) and a RNAi transgenic root (line PAT-11, lower) are sliced and allowed to develop PPD for a series of time. Samples are exposed under 360nm ultraviolet light and photographed with a PENTAX K20D camera at aperture f/0, exposure 1/30, and ISO-400. (0DAH) Little to no fluorescence; (1DAH) Strong fluorescence spread throughout the root; (3DAH) Fluorescence began to diminish in the deteriorated part; (5DAH) Fluorescence diminished from the majority of the root. DAH: days after harvest. 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01978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29</Words>
  <Application>Microsoft Office PowerPoint</Application>
  <PresentationFormat>全屏显示(4:3)</PresentationFormat>
  <Paragraphs>11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Liu</dc:creator>
  <cp:lastModifiedBy>Shi Liu</cp:lastModifiedBy>
  <cp:revision>9</cp:revision>
  <dcterms:created xsi:type="dcterms:W3CDTF">2017-03-08T05:15:04Z</dcterms:created>
  <dcterms:modified xsi:type="dcterms:W3CDTF">2017-03-08T11:44:10Z</dcterms:modified>
</cp:coreProperties>
</file>